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3" r:id="rId2"/>
    <p:sldId id="304" r:id="rId3"/>
    <p:sldId id="302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635" autoAdjust="0"/>
    <p:restoredTop sz="94660"/>
  </p:normalViewPr>
  <p:slideViewPr>
    <p:cSldViewPr snapToGrid="0">
      <p:cViewPr varScale="1">
        <p:scale>
          <a:sx n="55" d="100"/>
          <a:sy n="55" d="100"/>
        </p:scale>
        <p:origin x="12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Genus figure'!$DR$3</c:f>
              <c:strCache>
                <c:ptCount val="1"/>
                <c:pt idx="0">
                  <c:v>Alphatorqueviru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:$DU$3</c:f>
              <c:numCache>
                <c:formatCode>General</c:formatCode>
                <c:ptCount val="3"/>
                <c:pt idx="0">
                  <c:v>1.2881220869565217E-2</c:v>
                </c:pt>
                <c:pt idx="1">
                  <c:v>6.7591078214285713E-2</c:v>
                </c:pt>
                <c:pt idx="2">
                  <c:v>0.246421844413793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05-4514-A8CB-589438E5203E}"/>
            </c:ext>
          </c:extLst>
        </c:ser>
        <c:ser>
          <c:idx val="1"/>
          <c:order val="1"/>
          <c:tx>
            <c:strRef>
              <c:f>'Genus figure'!$DR$4</c:f>
              <c:strCache>
                <c:ptCount val="1"/>
                <c:pt idx="0">
                  <c:v>Rhodococc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4:$DU$4</c:f>
              <c:numCache>
                <c:formatCode>General</c:formatCode>
                <c:ptCount val="3"/>
                <c:pt idx="0">
                  <c:v>6.7359526804347827E-2</c:v>
                </c:pt>
                <c:pt idx="1">
                  <c:v>0.14460788214285714</c:v>
                </c:pt>
                <c:pt idx="2">
                  <c:v>0.100978369655172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005-4514-A8CB-589438E5203E}"/>
            </c:ext>
          </c:extLst>
        </c:ser>
        <c:ser>
          <c:idx val="2"/>
          <c:order val="2"/>
          <c:tx>
            <c:strRef>
              <c:f>'Genus figure'!$DR$5</c:f>
              <c:strCache>
                <c:ptCount val="1"/>
                <c:pt idx="0">
                  <c:v>Pseudomona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5:$DU$5</c:f>
              <c:numCache>
                <c:formatCode>General</c:formatCode>
                <c:ptCount val="3"/>
                <c:pt idx="0">
                  <c:v>7.3902258478260846E-2</c:v>
                </c:pt>
                <c:pt idx="1">
                  <c:v>6.3614650000000009E-2</c:v>
                </c:pt>
                <c:pt idx="2">
                  <c:v>6.786609344827587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005-4514-A8CB-589438E5203E}"/>
            </c:ext>
          </c:extLst>
        </c:ser>
        <c:ser>
          <c:idx val="3"/>
          <c:order val="3"/>
          <c:tx>
            <c:strRef>
              <c:f>'Genus figure'!$DR$6</c:f>
              <c:strCache>
                <c:ptCount val="1"/>
                <c:pt idx="0">
                  <c:v>Staphylococcu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6:$DU$6</c:f>
              <c:numCache>
                <c:formatCode>General</c:formatCode>
                <c:ptCount val="3"/>
                <c:pt idx="0">
                  <c:v>8.7253976086956536E-2</c:v>
                </c:pt>
                <c:pt idx="1">
                  <c:v>4.9733220714285716E-2</c:v>
                </c:pt>
                <c:pt idx="2">
                  <c:v>6.279822655172413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005-4514-A8CB-589438E5203E}"/>
            </c:ext>
          </c:extLst>
        </c:ser>
        <c:ser>
          <c:idx val="4"/>
          <c:order val="4"/>
          <c:tx>
            <c:strRef>
              <c:f>'Genus figure'!$DR$7</c:f>
              <c:strCache>
                <c:ptCount val="1"/>
                <c:pt idx="0">
                  <c:v>Cutibacteriu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7:$DU$7</c:f>
              <c:numCache>
                <c:formatCode>General</c:formatCode>
                <c:ptCount val="3"/>
                <c:pt idx="0">
                  <c:v>7.8230294347826079E-2</c:v>
                </c:pt>
                <c:pt idx="1">
                  <c:v>4.2267644285714279E-2</c:v>
                </c:pt>
                <c:pt idx="2">
                  <c:v>4.976406875862067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005-4514-A8CB-589438E5203E}"/>
            </c:ext>
          </c:extLst>
        </c:ser>
        <c:ser>
          <c:idx val="5"/>
          <c:order val="5"/>
          <c:tx>
            <c:strRef>
              <c:f>'Genus figure'!$DR$8</c:f>
              <c:strCache>
                <c:ptCount val="1"/>
                <c:pt idx="0">
                  <c:v>Acidovorax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8:$DU$8</c:f>
              <c:numCache>
                <c:formatCode>General</c:formatCode>
                <c:ptCount val="3"/>
                <c:pt idx="0">
                  <c:v>6.8789894565217377E-2</c:v>
                </c:pt>
                <c:pt idx="1">
                  <c:v>4.8538242142857138E-2</c:v>
                </c:pt>
                <c:pt idx="2">
                  <c:v>4.04663965517241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005-4514-A8CB-589438E5203E}"/>
            </c:ext>
          </c:extLst>
        </c:ser>
        <c:ser>
          <c:idx val="6"/>
          <c:order val="6"/>
          <c:tx>
            <c:strRef>
              <c:f>'Genus figure'!$DR$9</c:f>
              <c:strCache>
                <c:ptCount val="1"/>
                <c:pt idx="0">
                  <c:v>Citrobacter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9:$DU$9</c:f>
              <c:numCache>
                <c:formatCode>General</c:formatCode>
                <c:ptCount val="3"/>
                <c:pt idx="0">
                  <c:v>9.5558303478260873E-2</c:v>
                </c:pt>
                <c:pt idx="1">
                  <c:v>2.9313464285714286E-4</c:v>
                </c:pt>
                <c:pt idx="2">
                  <c:v>4.910134137931035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005-4514-A8CB-589438E5203E}"/>
            </c:ext>
          </c:extLst>
        </c:ser>
        <c:ser>
          <c:idx val="7"/>
          <c:order val="7"/>
          <c:tx>
            <c:strRef>
              <c:f>'Genus figure'!$DR$10</c:f>
              <c:strCache>
                <c:ptCount val="1"/>
                <c:pt idx="0">
                  <c:v>Variovorax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0:$DU$10</c:f>
              <c:numCache>
                <c:formatCode>General</c:formatCode>
                <c:ptCount val="3"/>
                <c:pt idx="0">
                  <c:v>2.052025895652174E-2</c:v>
                </c:pt>
                <c:pt idx="1">
                  <c:v>3.4985632857142859E-2</c:v>
                </c:pt>
                <c:pt idx="2">
                  <c:v>2.949990448275862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4005-4514-A8CB-589438E5203E}"/>
            </c:ext>
          </c:extLst>
        </c:ser>
        <c:ser>
          <c:idx val="8"/>
          <c:order val="8"/>
          <c:tx>
            <c:strRef>
              <c:f>'Genus figure'!$DR$11</c:f>
              <c:strCache>
                <c:ptCount val="1"/>
                <c:pt idx="0">
                  <c:v>Pa6virus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1:$DU$11</c:f>
              <c:numCache>
                <c:formatCode>General</c:formatCode>
                <c:ptCount val="3"/>
                <c:pt idx="0">
                  <c:v>5.5145660217391305E-2</c:v>
                </c:pt>
                <c:pt idx="1">
                  <c:v>7.5552617857142859E-3</c:v>
                </c:pt>
                <c:pt idx="2">
                  <c:v>8.430207586206895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005-4514-A8CB-589438E5203E}"/>
            </c:ext>
          </c:extLst>
        </c:ser>
        <c:ser>
          <c:idx val="9"/>
          <c:order val="9"/>
          <c:tx>
            <c:strRef>
              <c:f>'Genus figure'!$DR$12</c:f>
              <c:strCache>
                <c:ptCount val="1"/>
                <c:pt idx="0">
                  <c:v>Acinetobacter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2:$DU$12</c:f>
              <c:numCache>
                <c:formatCode>General</c:formatCode>
                <c:ptCount val="3"/>
                <c:pt idx="0">
                  <c:v>1.6612536347826088E-2</c:v>
                </c:pt>
                <c:pt idx="1">
                  <c:v>4.4682760000000002E-2</c:v>
                </c:pt>
                <c:pt idx="2">
                  <c:v>9.696405862068966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4005-4514-A8CB-589438E5203E}"/>
            </c:ext>
          </c:extLst>
        </c:ser>
        <c:ser>
          <c:idx val="10"/>
          <c:order val="10"/>
          <c:tx>
            <c:strRef>
              <c:f>'Genus figure'!$DR$13</c:f>
              <c:strCache>
                <c:ptCount val="1"/>
                <c:pt idx="0">
                  <c:v>Corynebacterium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3:$DU$13</c:f>
              <c:numCache>
                <c:formatCode>General</c:formatCode>
                <c:ptCount val="3"/>
                <c:pt idx="0">
                  <c:v>3.6429146956521746E-2</c:v>
                </c:pt>
                <c:pt idx="1">
                  <c:v>1.4037846428571426E-2</c:v>
                </c:pt>
                <c:pt idx="2">
                  <c:v>1.909354896551723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005-4514-A8CB-589438E5203E}"/>
            </c:ext>
          </c:extLst>
        </c:ser>
        <c:ser>
          <c:idx val="11"/>
          <c:order val="11"/>
          <c:tx>
            <c:strRef>
              <c:f>'Genus figure'!$DR$14</c:f>
              <c:strCache>
                <c:ptCount val="1"/>
                <c:pt idx="0">
                  <c:v>Enterococcu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4:$DU$14</c:f>
              <c:numCache>
                <c:formatCode>General</c:formatCode>
                <c:ptCount val="3"/>
                <c:pt idx="0">
                  <c:v>1.1615297173913044E-2</c:v>
                </c:pt>
                <c:pt idx="1">
                  <c:v>2.9992364999999997E-2</c:v>
                </c:pt>
                <c:pt idx="2">
                  <c:v>2.52272510000000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4005-4514-A8CB-589438E5203E}"/>
            </c:ext>
          </c:extLst>
        </c:ser>
        <c:ser>
          <c:idx val="12"/>
          <c:order val="12"/>
          <c:tx>
            <c:strRef>
              <c:f>'Genus figure'!$DR$15</c:f>
              <c:strCache>
                <c:ptCount val="1"/>
                <c:pt idx="0">
                  <c:v>Cytomegaloviru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5:$DU$15</c:f>
              <c:numCache>
                <c:formatCode>General</c:formatCode>
                <c:ptCount val="3"/>
                <c:pt idx="0">
                  <c:v>1.572445239130435E-2</c:v>
                </c:pt>
                <c:pt idx="1">
                  <c:v>3.2066508571428565E-2</c:v>
                </c:pt>
                <c:pt idx="2">
                  <c:v>1.138837444827586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005-4514-A8CB-589438E5203E}"/>
            </c:ext>
          </c:extLst>
        </c:ser>
        <c:ser>
          <c:idx val="13"/>
          <c:order val="13"/>
          <c:tx>
            <c:strRef>
              <c:f>'Genus figure'!$DR$16</c:f>
              <c:strCache>
                <c:ptCount val="1"/>
                <c:pt idx="0">
                  <c:v>Propionibacterium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6:$DU$16</c:f>
              <c:numCache>
                <c:formatCode>General</c:formatCode>
                <c:ptCount val="3"/>
                <c:pt idx="0">
                  <c:v>2.0487935543478261E-2</c:v>
                </c:pt>
                <c:pt idx="1">
                  <c:v>2.3850975000000003E-2</c:v>
                </c:pt>
                <c:pt idx="2">
                  <c:v>1.417136862068965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4005-4514-A8CB-589438E5203E}"/>
            </c:ext>
          </c:extLst>
        </c:ser>
        <c:ser>
          <c:idx val="14"/>
          <c:order val="14"/>
          <c:tx>
            <c:strRef>
              <c:f>'Genus figure'!$DR$17</c:f>
              <c:strCache>
                <c:ptCount val="1"/>
                <c:pt idx="0">
                  <c:v>Methylobacterium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7:$DU$17</c:f>
              <c:numCache>
                <c:formatCode>General</c:formatCode>
                <c:ptCount val="3"/>
                <c:pt idx="0">
                  <c:v>1.3285985391304345E-2</c:v>
                </c:pt>
                <c:pt idx="1">
                  <c:v>2.3976843928571433E-2</c:v>
                </c:pt>
                <c:pt idx="2">
                  <c:v>1.463051103448275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4005-4514-A8CB-589438E5203E}"/>
            </c:ext>
          </c:extLst>
        </c:ser>
        <c:ser>
          <c:idx val="15"/>
          <c:order val="15"/>
          <c:tx>
            <c:strRef>
              <c:f>'Genus figure'!$DR$18</c:f>
              <c:strCache>
                <c:ptCount val="1"/>
                <c:pt idx="0">
                  <c:v>Stenotrophomonas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8:$DU$18</c:f>
              <c:numCache>
                <c:formatCode>General</c:formatCode>
                <c:ptCount val="3"/>
                <c:pt idx="0">
                  <c:v>5.7157889130434788E-3</c:v>
                </c:pt>
                <c:pt idx="1">
                  <c:v>3.3653164285714285E-3</c:v>
                </c:pt>
                <c:pt idx="2">
                  <c:v>3.589946620689655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4005-4514-A8CB-589438E5203E}"/>
            </c:ext>
          </c:extLst>
        </c:ser>
        <c:ser>
          <c:idx val="16"/>
          <c:order val="16"/>
          <c:tx>
            <c:strRef>
              <c:f>'Genus figure'!$DR$19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19:$DU$19</c:f>
              <c:numCache>
                <c:formatCode>General</c:formatCode>
                <c:ptCount val="3"/>
                <c:pt idx="0">
                  <c:v>1.4165707826086954E-2</c:v>
                </c:pt>
                <c:pt idx="1">
                  <c:v>2.0930094285714285E-2</c:v>
                </c:pt>
                <c:pt idx="2">
                  <c:v>6.598159310344827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4005-4514-A8CB-589438E5203E}"/>
            </c:ext>
          </c:extLst>
        </c:ser>
        <c:ser>
          <c:idx val="17"/>
          <c:order val="17"/>
          <c:tx>
            <c:strRef>
              <c:f>'Genus figure'!$DR$20</c:f>
              <c:strCache>
                <c:ptCount val="1"/>
                <c:pt idx="0">
                  <c:v>Ottowia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0:$DU$20</c:f>
              <c:numCache>
                <c:formatCode>General</c:formatCode>
                <c:ptCount val="3"/>
                <c:pt idx="0">
                  <c:v>9.9578758695652164E-3</c:v>
                </c:pt>
                <c:pt idx="1">
                  <c:v>1.7417588571428576E-2</c:v>
                </c:pt>
                <c:pt idx="2">
                  <c:v>1.375320379310345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4005-4514-A8CB-589438E5203E}"/>
            </c:ext>
          </c:extLst>
        </c:ser>
        <c:ser>
          <c:idx val="18"/>
          <c:order val="18"/>
          <c:tx>
            <c:strRef>
              <c:f>'Genus figure'!$DR$21</c:f>
              <c:strCache>
                <c:ptCount val="1"/>
                <c:pt idx="0">
                  <c:v>Micrococcus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1:$DU$21</c:f>
              <c:numCache>
                <c:formatCode>General</c:formatCode>
                <c:ptCount val="3"/>
                <c:pt idx="0">
                  <c:v>1.3824113260869565E-2</c:v>
                </c:pt>
                <c:pt idx="1">
                  <c:v>8.3491878571428577E-3</c:v>
                </c:pt>
                <c:pt idx="2">
                  <c:v>1.38948230000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4005-4514-A8CB-589438E5203E}"/>
            </c:ext>
          </c:extLst>
        </c:ser>
        <c:ser>
          <c:idx val="19"/>
          <c:order val="19"/>
          <c:tx>
            <c:strRef>
              <c:f>'Genus figure'!$DR$22</c:f>
              <c:strCache>
                <c:ptCount val="1"/>
                <c:pt idx="0">
                  <c:v>Enterobacter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2:$DU$22</c:f>
              <c:numCache>
                <c:formatCode>General</c:formatCode>
                <c:ptCount val="3"/>
                <c:pt idx="0">
                  <c:v>1.0908570608695654E-2</c:v>
                </c:pt>
                <c:pt idx="1">
                  <c:v>1.7314527857142856E-2</c:v>
                </c:pt>
                <c:pt idx="2">
                  <c:v>7.780091379310343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4005-4514-A8CB-589438E5203E}"/>
            </c:ext>
          </c:extLst>
        </c:ser>
        <c:ser>
          <c:idx val="20"/>
          <c:order val="20"/>
          <c:tx>
            <c:strRef>
              <c:f>'Genus figure'!$DR$23</c:f>
              <c:strCache>
                <c:ptCount val="1"/>
                <c:pt idx="0">
                  <c:v>Burkholderia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3:$DU$23</c:f>
              <c:numCache>
                <c:formatCode>General</c:formatCode>
                <c:ptCount val="3"/>
                <c:pt idx="0">
                  <c:v>9.7575070000000021E-3</c:v>
                </c:pt>
                <c:pt idx="1">
                  <c:v>1.3637215357142856E-2</c:v>
                </c:pt>
                <c:pt idx="2">
                  <c:v>1.131155689655172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4005-4514-A8CB-589438E5203E}"/>
            </c:ext>
          </c:extLst>
        </c:ser>
        <c:ser>
          <c:idx val="21"/>
          <c:order val="21"/>
          <c:tx>
            <c:strRef>
              <c:f>'Genus figure'!$DR$24</c:f>
              <c:strCache>
                <c:ptCount val="1"/>
                <c:pt idx="0">
                  <c:v>Microbacterium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4:$DU$24</c:f>
              <c:numCache>
                <c:formatCode>General</c:formatCode>
                <c:ptCount val="3"/>
                <c:pt idx="0">
                  <c:v>4.1820781739130442E-3</c:v>
                </c:pt>
                <c:pt idx="1">
                  <c:v>1.447570464285714E-2</c:v>
                </c:pt>
                <c:pt idx="2">
                  <c:v>1.18221427586206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4005-4514-A8CB-589438E5203E}"/>
            </c:ext>
          </c:extLst>
        </c:ser>
        <c:ser>
          <c:idx val="22"/>
          <c:order val="22"/>
          <c:tx>
            <c:strRef>
              <c:f>'Genus figure'!$DR$25</c:f>
              <c:strCache>
                <c:ptCount val="1"/>
                <c:pt idx="0">
                  <c:v>Moraxella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5:$DU$25</c:f>
              <c:numCache>
                <c:formatCode>General</c:formatCode>
                <c:ptCount val="3"/>
                <c:pt idx="0">
                  <c:v>6.6455584782608703E-3</c:v>
                </c:pt>
                <c:pt idx="1">
                  <c:v>9.430528214285713E-3</c:v>
                </c:pt>
                <c:pt idx="2">
                  <c:v>1.350636655172414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4005-4514-A8CB-589438E5203E}"/>
            </c:ext>
          </c:extLst>
        </c:ser>
        <c:ser>
          <c:idx val="23"/>
          <c:order val="23"/>
          <c:tx>
            <c:strRef>
              <c:f>'Genus figure'!$DR$26</c:f>
              <c:strCache>
                <c:ptCount val="1"/>
                <c:pt idx="0">
                  <c:v>Xanthomonas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6:$DU$26</c:f>
              <c:numCache>
                <c:formatCode>General</c:formatCode>
                <c:ptCount val="3"/>
                <c:pt idx="0">
                  <c:v>4.3499607608695661E-3</c:v>
                </c:pt>
                <c:pt idx="1">
                  <c:v>2.296797357142857E-2</c:v>
                </c:pt>
                <c:pt idx="2">
                  <c:v>1.647231034482758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4005-4514-A8CB-589438E5203E}"/>
            </c:ext>
          </c:extLst>
        </c:ser>
        <c:ser>
          <c:idx val="24"/>
          <c:order val="24"/>
          <c:tx>
            <c:strRef>
              <c:f>'Genus figure'!$DR$27</c:f>
              <c:strCache>
                <c:ptCount val="1"/>
                <c:pt idx="0">
                  <c:v>Escherichia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7:$DU$27</c:f>
              <c:numCache>
                <c:formatCode>General</c:formatCode>
                <c:ptCount val="3"/>
                <c:pt idx="0">
                  <c:v>1.4547617391304347E-2</c:v>
                </c:pt>
                <c:pt idx="1">
                  <c:v>5.4647664285714295E-3</c:v>
                </c:pt>
                <c:pt idx="2">
                  <c:v>5.421889896551725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4005-4514-A8CB-589438E5203E}"/>
            </c:ext>
          </c:extLst>
        </c:ser>
        <c:ser>
          <c:idx val="25"/>
          <c:order val="25"/>
          <c:tx>
            <c:strRef>
              <c:f>'Genus figure'!$DR$28</c:f>
              <c:strCache>
                <c:ptCount val="1"/>
                <c:pt idx="0">
                  <c:v>Diaphorobacter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8:$DU$28</c:f>
              <c:numCache>
                <c:formatCode>General</c:formatCode>
                <c:ptCount val="3"/>
                <c:pt idx="0">
                  <c:v>1.3609374130434783E-2</c:v>
                </c:pt>
                <c:pt idx="1">
                  <c:v>5.7646953571428563E-3</c:v>
                </c:pt>
                <c:pt idx="2">
                  <c:v>5.886857931034483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4005-4514-A8CB-589438E5203E}"/>
            </c:ext>
          </c:extLst>
        </c:ser>
        <c:ser>
          <c:idx val="26"/>
          <c:order val="26"/>
          <c:tx>
            <c:strRef>
              <c:f>'Genus figure'!$DR$29</c:f>
              <c:strCache>
                <c:ptCount val="1"/>
                <c:pt idx="0">
                  <c:v>Sphingobium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29:$DU$29</c:f>
              <c:numCache>
                <c:formatCode>General</c:formatCode>
                <c:ptCount val="3"/>
                <c:pt idx="0">
                  <c:v>1.2191040652173914E-2</c:v>
                </c:pt>
                <c:pt idx="1">
                  <c:v>5.6330303571428559E-3</c:v>
                </c:pt>
                <c:pt idx="2">
                  <c:v>5.257086896551723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4005-4514-A8CB-589438E5203E}"/>
            </c:ext>
          </c:extLst>
        </c:ser>
        <c:ser>
          <c:idx val="27"/>
          <c:order val="27"/>
          <c:tx>
            <c:strRef>
              <c:f>'Genus figure'!$DR$30</c:f>
              <c:strCache>
                <c:ptCount val="1"/>
                <c:pt idx="0">
                  <c:v>Sphingomonas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0:$DU$30</c:f>
              <c:numCache>
                <c:formatCode>General</c:formatCode>
                <c:ptCount val="3"/>
                <c:pt idx="0">
                  <c:v>6.6236633913043467E-3</c:v>
                </c:pt>
                <c:pt idx="1">
                  <c:v>7.5955349999999996E-3</c:v>
                </c:pt>
                <c:pt idx="2">
                  <c:v>7.458109310344828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4005-4514-A8CB-589438E5203E}"/>
            </c:ext>
          </c:extLst>
        </c:ser>
        <c:ser>
          <c:idx val="28"/>
          <c:order val="28"/>
          <c:tx>
            <c:strRef>
              <c:f>'Genus figure'!$DR$31</c:f>
              <c:strCache>
                <c:ptCount val="1"/>
                <c:pt idx="0">
                  <c:v>Simplexvirus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1:$DU$31</c:f>
              <c:numCache>
                <c:formatCode>General</c:formatCode>
                <c:ptCount val="3"/>
                <c:pt idx="0">
                  <c:v>3.6074892826086962E-3</c:v>
                </c:pt>
                <c:pt idx="1">
                  <c:v>1.0880607142857143E-2</c:v>
                </c:pt>
                <c:pt idx="2">
                  <c:v>5.13572413793103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4005-4514-A8CB-589438E5203E}"/>
            </c:ext>
          </c:extLst>
        </c:ser>
        <c:ser>
          <c:idx val="29"/>
          <c:order val="29"/>
          <c:tx>
            <c:strRef>
              <c:f>'Genus figure'!$DR$32</c:f>
              <c:strCache>
                <c:ptCount val="1"/>
                <c:pt idx="0">
                  <c:v>Aeromonas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2:$DU$32</c:f>
              <c:numCache>
                <c:formatCode>General</c:formatCode>
                <c:ptCount val="3"/>
                <c:pt idx="0">
                  <c:v>7.0834858260869563E-3</c:v>
                </c:pt>
                <c:pt idx="1">
                  <c:v>7.7117367857142865E-3</c:v>
                </c:pt>
                <c:pt idx="2">
                  <c:v>4.623193793103448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4005-4514-A8CB-589438E5203E}"/>
            </c:ext>
          </c:extLst>
        </c:ser>
        <c:ser>
          <c:idx val="30"/>
          <c:order val="30"/>
          <c:tx>
            <c:strRef>
              <c:f>'Genus figure'!$DR$33</c:f>
              <c:strCache>
                <c:ptCount val="1"/>
                <c:pt idx="0">
                  <c:v>Delftia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3:$DU$33</c:f>
              <c:numCache>
                <c:formatCode>General</c:formatCode>
                <c:ptCount val="3"/>
                <c:pt idx="0">
                  <c:v>7.818683717391306E-3</c:v>
                </c:pt>
                <c:pt idx="1">
                  <c:v>4.4908171428571422E-3</c:v>
                </c:pt>
                <c:pt idx="2">
                  <c:v>5.403693689655171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4005-4514-A8CB-589438E5203E}"/>
            </c:ext>
          </c:extLst>
        </c:ser>
        <c:ser>
          <c:idx val="31"/>
          <c:order val="31"/>
          <c:tx>
            <c:strRef>
              <c:f>'Genus figure'!$DR$34</c:f>
              <c:strCache>
                <c:ptCount val="1"/>
                <c:pt idx="0">
                  <c:v>Varicelloviru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4:$DU$34</c:f>
              <c:numCache>
                <c:formatCode>General</c:formatCode>
                <c:ptCount val="3"/>
                <c:pt idx="0">
                  <c:v>1.3498695652173912E-3</c:v>
                </c:pt>
                <c:pt idx="1">
                  <c:v>9.6786428571428579E-3</c:v>
                </c:pt>
                <c:pt idx="2">
                  <c:v>5.898775862068965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4005-4514-A8CB-589438E5203E}"/>
            </c:ext>
          </c:extLst>
        </c:ser>
        <c:ser>
          <c:idx val="32"/>
          <c:order val="32"/>
          <c:tx>
            <c:strRef>
              <c:f>'Genus figure'!$DR$35</c:f>
              <c:strCache>
                <c:ptCount val="1"/>
                <c:pt idx="0">
                  <c:v>Dermacoccus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5:$DU$35</c:f>
              <c:numCache>
                <c:formatCode>General</c:formatCode>
                <c:ptCount val="3"/>
                <c:pt idx="0">
                  <c:v>4.1443455000000004E-3</c:v>
                </c:pt>
                <c:pt idx="1">
                  <c:v>7.039145000000001E-3</c:v>
                </c:pt>
                <c:pt idx="2">
                  <c:v>4.793438206896550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4005-4514-A8CB-589438E5203E}"/>
            </c:ext>
          </c:extLst>
        </c:ser>
        <c:ser>
          <c:idx val="33"/>
          <c:order val="33"/>
          <c:tx>
            <c:strRef>
              <c:f>'Genus figure'!$DR$36</c:f>
              <c:strCache>
                <c:ptCount val="1"/>
                <c:pt idx="0">
                  <c:v>Hydrogenophilus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6:$DU$36</c:f>
              <c:numCache>
                <c:formatCode>General</c:formatCode>
                <c:ptCount val="3"/>
                <c:pt idx="0">
                  <c:v>1.1183297391304348E-2</c:v>
                </c:pt>
                <c:pt idx="1">
                  <c:v>3.1933256071428567E-3</c:v>
                </c:pt>
                <c:pt idx="2">
                  <c:v>1.057043103448276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4005-4514-A8CB-589438E5203E}"/>
            </c:ext>
          </c:extLst>
        </c:ser>
        <c:ser>
          <c:idx val="34"/>
          <c:order val="34"/>
          <c:tx>
            <c:strRef>
              <c:f>'Genus figure'!$DR$37</c:f>
              <c:strCache>
                <c:ptCount val="1"/>
                <c:pt idx="0">
                  <c:v>Janthinobacterium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7:$DU$37</c:f>
              <c:numCache>
                <c:formatCode>General</c:formatCode>
                <c:ptCount val="3"/>
                <c:pt idx="0">
                  <c:v>5.5967889565217395E-3</c:v>
                </c:pt>
                <c:pt idx="1">
                  <c:v>5.3168249999999998E-3</c:v>
                </c:pt>
                <c:pt idx="2">
                  <c:v>3.1490874827586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4005-4514-A8CB-589438E5203E}"/>
            </c:ext>
          </c:extLst>
        </c:ser>
        <c:ser>
          <c:idx val="35"/>
          <c:order val="35"/>
          <c:tx>
            <c:strRef>
              <c:f>'Genus figure'!$DR$38</c:f>
              <c:strCache>
                <c:ptCount val="1"/>
                <c:pt idx="0">
                  <c:v>Cupriavidus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8:$DU$38</c:f>
              <c:numCache>
                <c:formatCode>General</c:formatCode>
                <c:ptCount val="3"/>
                <c:pt idx="0">
                  <c:v>3.8690048913043481E-3</c:v>
                </c:pt>
                <c:pt idx="1">
                  <c:v>5.4466774999999993E-3</c:v>
                </c:pt>
                <c:pt idx="2">
                  <c:v>3.967661379310344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3-4005-4514-A8CB-589438E5203E}"/>
            </c:ext>
          </c:extLst>
        </c:ser>
        <c:ser>
          <c:idx val="36"/>
          <c:order val="36"/>
          <c:tx>
            <c:strRef>
              <c:f>'Genus figure'!$DR$39</c:f>
              <c:strCache>
                <c:ptCount val="1"/>
                <c:pt idx="0">
                  <c:v>Methylorubrum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39:$DU$39</c:f>
              <c:numCache>
                <c:formatCode>General</c:formatCode>
                <c:ptCount val="3"/>
                <c:pt idx="0">
                  <c:v>4.3696482608695649E-3</c:v>
                </c:pt>
                <c:pt idx="1">
                  <c:v>4.2273982142857144E-3</c:v>
                </c:pt>
                <c:pt idx="2">
                  <c:v>4.483914137931034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4005-4514-A8CB-589438E5203E}"/>
            </c:ext>
          </c:extLst>
        </c:ser>
        <c:ser>
          <c:idx val="37"/>
          <c:order val="37"/>
          <c:tx>
            <c:strRef>
              <c:f>'Genus figure'!$DR$40</c:f>
              <c:strCache>
                <c:ptCount val="1"/>
                <c:pt idx="0">
                  <c:v>Ralstonia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40:$DU$40</c:f>
              <c:numCache>
                <c:formatCode>General</c:formatCode>
                <c:ptCount val="3"/>
                <c:pt idx="0">
                  <c:v>2.0664646956521739E-3</c:v>
                </c:pt>
                <c:pt idx="1">
                  <c:v>7.5308453571428574E-3</c:v>
                </c:pt>
                <c:pt idx="2">
                  <c:v>2.69136506896551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5-4005-4514-A8CB-589438E5203E}"/>
            </c:ext>
          </c:extLst>
        </c:ser>
        <c:ser>
          <c:idx val="38"/>
          <c:order val="38"/>
          <c:tx>
            <c:strRef>
              <c:f>'Genus figure'!$DR$41</c:f>
              <c:strCache>
                <c:ptCount val="1"/>
                <c:pt idx="0">
                  <c:v>Bradyrhizobium</c:v>
                </c:pt>
              </c:strCache>
            </c:strRef>
          </c:tx>
          <c:spPr>
            <a:solidFill>
              <a:schemeClr val="accent3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41:$DU$41</c:f>
              <c:numCache>
                <c:formatCode>General</c:formatCode>
                <c:ptCount val="3"/>
                <c:pt idx="0">
                  <c:v>4.5163605869565221E-3</c:v>
                </c:pt>
                <c:pt idx="1">
                  <c:v>3.8854046428571419E-3</c:v>
                </c:pt>
                <c:pt idx="2">
                  <c:v>3.483099655172414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4005-4514-A8CB-589438E5203E}"/>
            </c:ext>
          </c:extLst>
        </c:ser>
        <c:ser>
          <c:idx val="39"/>
          <c:order val="39"/>
          <c:tx>
            <c:strRef>
              <c:f>'Genus figure'!$DR$42</c:f>
              <c:strCache>
                <c:ptCount val="1"/>
                <c:pt idx="0">
                  <c:v>Bacillus</c:v>
                </c:pt>
              </c:strCache>
            </c:strRef>
          </c:tx>
          <c:spPr>
            <a:solidFill>
              <a:schemeClr val="accent4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42:$DU$42</c:f>
              <c:numCache>
                <c:formatCode>General</c:formatCode>
                <c:ptCount val="3"/>
                <c:pt idx="0">
                  <c:v>5.2119184130434773E-3</c:v>
                </c:pt>
                <c:pt idx="1">
                  <c:v>4.0947453571428564E-3</c:v>
                </c:pt>
                <c:pt idx="2">
                  <c:v>2.467489310344827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4005-4514-A8CB-589438E5203E}"/>
            </c:ext>
          </c:extLst>
        </c:ser>
        <c:ser>
          <c:idx val="40"/>
          <c:order val="40"/>
          <c:tx>
            <c:strRef>
              <c:f>'Genus figure'!$DR$43</c:f>
              <c:strCache>
                <c:ptCount val="1"/>
                <c:pt idx="0">
                  <c:v>Comamonas</c:v>
                </c:pt>
              </c:strCache>
            </c:strRef>
          </c:tx>
          <c:spPr>
            <a:solidFill>
              <a:schemeClr val="accent5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43:$DU$43</c:f>
              <c:numCache>
                <c:formatCode>General</c:formatCode>
                <c:ptCount val="3"/>
                <c:pt idx="0">
                  <c:v>3.8058872608695651E-3</c:v>
                </c:pt>
                <c:pt idx="1">
                  <c:v>4.4502207142857134E-3</c:v>
                </c:pt>
                <c:pt idx="2">
                  <c:v>2.894916551724138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8-4005-4514-A8CB-589438E5203E}"/>
            </c:ext>
          </c:extLst>
        </c:ser>
        <c:ser>
          <c:idx val="41"/>
          <c:order val="41"/>
          <c:tx>
            <c:strRef>
              <c:f>'Genus figure'!$DR$44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accent6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Genus figure'!$DS$2:$DU$2</c:f>
              <c:strCache>
                <c:ptCount val="3"/>
                <c:pt idx="0">
                  <c:v>1 week</c:v>
                </c:pt>
                <c:pt idx="1">
                  <c:v>4 week</c:v>
                </c:pt>
                <c:pt idx="2">
                  <c:v>8 week</c:v>
                </c:pt>
              </c:strCache>
            </c:strRef>
          </c:cat>
          <c:val>
            <c:numRef>
              <c:f>'Genus figure'!$DS$44:$DU$44</c:f>
              <c:numCache>
                <c:formatCode>General</c:formatCode>
                <c:ptCount val="3"/>
                <c:pt idx="0">
                  <c:v>0.13510120491304325</c:v>
                </c:pt>
                <c:pt idx="1">
                  <c:v>0.14191344014285712</c:v>
                </c:pt>
                <c:pt idx="2">
                  <c:v>0.108789866137931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9-4005-4514-A8CB-589438E520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8"/>
        <c:overlap val="100"/>
        <c:axId val="2073159567"/>
        <c:axId val="2073163311"/>
      </c:barChart>
      <c:catAx>
        <c:axId val="20731595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73163311"/>
        <c:crosses val="autoZero"/>
        <c:auto val="1"/>
        <c:lblAlgn val="ctr"/>
        <c:lblOffset val="100"/>
        <c:noMultiLvlLbl val="0"/>
      </c:catAx>
      <c:valAx>
        <c:axId val="2073163311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7315956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41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1.4474194947271785E-2"/>
          <c:y val="0.49282636720398715"/>
          <c:w val="0.96809656133907351"/>
          <c:h val="0.3648827931841732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451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7138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9267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1276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581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9215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038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0466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035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865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543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090C3-F786-4EC3-9F4F-E0D81CE24B71}" type="datetimeFigureOut">
              <a:rPr kumimoji="1" lang="ja-JP" altLang="en-US" smtClean="0"/>
              <a:t>2021/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BD79A9-76F7-4A0D-8726-5FBD9F2A6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680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9708D265-8442-4EBB-872F-B7E0E49FDD59}"/>
              </a:ext>
            </a:extLst>
          </p:cNvPr>
          <p:cNvGraphicFramePr>
            <a:graphicFrameLocks/>
          </p:cNvGraphicFramePr>
          <p:nvPr/>
        </p:nvGraphicFramePr>
        <p:xfrm>
          <a:off x="296334" y="296332"/>
          <a:ext cx="3428999" cy="60729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267" name="テキスト ボックス 1">
            <a:extLst>
              <a:ext uri="{FF2B5EF4-FFF2-40B4-BE49-F238E27FC236}">
                <a16:creationId xmlns:a16="http://schemas.microsoft.com/office/drawing/2014/main" id="{791FA7A0-8158-43CD-96E2-278ECF4CD47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06916" y="1592739"/>
            <a:ext cx="12065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elative Abundanc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68" name="テキスト ボックス 1">
            <a:extLst>
              <a:ext uri="{FF2B5EF4-FFF2-40B4-BE49-F238E27FC236}">
                <a16:creationId xmlns:a16="http://schemas.microsoft.com/office/drawing/2014/main" id="{ECDF6B35-54B6-403C-B1F1-674FEDA34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5338" y="2824163"/>
            <a:ext cx="2727325" cy="36988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1                            4                           8</a:t>
            </a:r>
          </a:p>
          <a:p>
            <a:pPr algn="ctr" eaLnBrk="1" hangingPunct="1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Week Post-transplantation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69" name="テキスト ボックス 157">
            <a:extLst>
              <a:ext uri="{FF2B5EF4-FFF2-40B4-BE49-F238E27FC236}">
                <a16:creationId xmlns:a16="http://schemas.microsoft.com/office/drawing/2014/main" id="{819BF3CC-6213-49B9-8C88-22B6C5F68A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913" y="6089650"/>
            <a:ext cx="31543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290" name="グラフ 5">
            <a:extLst>
              <a:ext uri="{FF2B5EF4-FFF2-40B4-BE49-F238E27FC236}">
                <a16:creationId xmlns:a16="http://schemas.microsoft.com/office/drawing/2014/main" id="{65AD521C-0A9F-4F0A-B3AE-15F9446986CF}"/>
              </a:ext>
            </a:extLst>
          </p:cNvPr>
          <p:cNvGraphicFramePr>
            <a:graphicFrameLocks/>
          </p:cNvGraphicFramePr>
          <p:nvPr/>
        </p:nvGraphicFramePr>
        <p:xfrm>
          <a:off x="1676400" y="182563"/>
          <a:ext cx="3505200" cy="3289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art" r:id="rId2" imgW="3505504" imgH="3292125" progId="Excel.Chart.8">
                  <p:embed/>
                </p:oleObj>
              </mc:Choice>
              <mc:Fallback>
                <p:oleObj name="Chart" r:id="rId2" imgW="3505504" imgH="3292125" progId="Excel.Chart.8">
                  <p:embed/>
                  <p:pic>
                    <p:nvPicPr>
                      <p:cNvPr id="12290" name="グラフ 5">
                        <a:extLst>
                          <a:ext uri="{FF2B5EF4-FFF2-40B4-BE49-F238E27FC236}">
                            <a16:creationId xmlns:a16="http://schemas.microsoft.com/office/drawing/2014/main" id="{65AD521C-0A9F-4F0A-B3AE-15F9446986CF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76400" y="182563"/>
                        <a:ext cx="3505200" cy="32893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291" name="テキスト ボックス 1">
            <a:extLst>
              <a:ext uri="{FF2B5EF4-FFF2-40B4-BE49-F238E27FC236}">
                <a16:creationId xmlns:a16="http://schemas.microsoft.com/office/drawing/2014/main" id="{B55FB74B-7FD2-467D-88C4-934C9B79CF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9963" y="3184525"/>
            <a:ext cx="2725737" cy="36988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1                            4                           8</a:t>
            </a:r>
          </a:p>
          <a:p>
            <a:pPr algn="ctr" eaLnBrk="1" hangingPunct="1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Week Post-transplantation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92" name="テキスト ボックス 1">
            <a:extLst>
              <a:ext uri="{FF2B5EF4-FFF2-40B4-BE49-F238E27FC236}">
                <a16:creationId xmlns:a16="http://schemas.microsoft.com/office/drawing/2014/main" id="{4DE2A606-DE02-4575-A139-8CF0B8A098BE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1123951" y="1711325"/>
            <a:ext cx="12065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Relative Abundance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293" name="図 16">
            <a:extLst>
              <a:ext uri="{FF2B5EF4-FFF2-40B4-BE49-F238E27FC236}">
                <a16:creationId xmlns:a16="http://schemas.microsoft.com/office/drawing/2014/main" id="{6B26CF8E-5366-4620-8648-86946D44182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862" r="4642"/>
          <a:stretch>
            <a:fillRect/>
          </a:stretch>
        </p:blipFill>
        <p:spPr bwMode="auto">
          <a:xfrm>
            <a:off x="333375" y="3554413"/>
            <a:ext cx="6538913" cy="44942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294" name="テキスト ボックス 157">
            <a:extLst>
              <a:ext uri="{FF2B5EF4-FFF2-40B4-BE49-F238E27FC236}">
                <a16:creationId xmlns:a16="http://schemas.microsoft.com/office/drawing/2014/main" id="{435D77E8-E6E3-4675-BA44-1B21510E2C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9225" y="8356600"/>
            <a:ext cx="3154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テキスト ボックス 157">
            <a:extLst>
              <a:ext uri="{FF2B5EF4-FFF2-40B4-BE49-F238E27FC236}">
                <a16:creationId xmlns:a16="http://schemas.microsoft.com/office/drawing/2014/main" id="{F68F5EC8-9F9A-47A3-97FC-49645C4833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525" y="3624263"/>
            <a:ext cx="315436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ja-JP" sz="900">
                <a:latin typeface="Arial" panose="020B0604020202020204" pitchFamily="34" charset="0"/>
                <a:cs typeface="Arial" panose="020B0604020202020204" pitchFamily="34" charset="0"/>
              </a:rPr>
              <a:t>Figure S3 </a:t>
            </a:r>
            <a:endParaRPr kumimoji="1" lang="en-US" altLang="ja-JP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43" name="グループ化 2">
            <a:extLst>
              <a:ext uri="{FF2B5EF4-FFF2-40B4-BE49-F238E27FC236}">
                <a16:creationId xmlns:a16="http://schemas.microsoft.com/office/drawing/2014/main" id="{D845E4BD-CCD8-4E9E-A44D-C82483FF3475}"/>
              </a:ext>
            </a:extLst>
          </p:cNvPr>
          <p:cNvGrpSpPr>
            <a:grpSpLocks/>
          </p:cNvGrpSpPr>
          <p:nvPr/>
        </p:nvGrpSpPr>
        <p:grpSpPr bwMode="auto">
          <a:xfrm>
            <a:off x="301625" y="184150"/>
            <a:ext cx="3370263" cy="3373438"/>
            <a:chOff x="302057" y="184151"/>
            <a:chExt cx="3370209" cy="3373437"/>
          </a:xfrm>
        </p:grpSpPr>
        <p:grpSp>
          <p:nvGrpSpPr>
            <p:cNvPr id="10244" name="グループ化 1">
              <a:extLst>
                <a:ext uri="{FF2B5EF4-FFF2-40B4-BE49-F238E27FC236}">
                  <a16:creationId xmlns:a16="http://schemas.microsoft.com/office/drawing/2014/main" id="{6F1F88B8-BBAE-40EA-A68B-D2D11A13809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17513" y="184151"/>
              <a:ext cx="3102353" cy="3373437"/>
              <a:chOff x="3616324" y="596901"/>
              <a:chExt cx="3102353" cy="3373437"/>
            </a:xfrm>
          </p:grpSpPr>
          <p:graphicFrame>
            <p:nvGraphicFramePr>
              <p:cNvPr id="10256" name="グラフ 8">
                <a:extLst>
                  <a:ext uri="{FF2B5EF4-FFF2-40B4-BE49-F238E27FC236}">
                    <a16:creationId xmlns:a16="http://schemas.microsoft.com/office/drawing/2014/main" id="{58CBEEFE-CFEB-4EE6-B648-50BFDF1816EB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3565524" y="546101"/>
              <a:ext cx="3203953" cy="335914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hart" r:id="rId2" imgW="3206774" imgH="3365284" progId="Excel.Chart.8">
                      <p:embed/>
                    </p:oleObj>
                  </mc:Choice>
                  <mc:Fallback>
                    <p:oleObj name="Chart" r:id="rId2" imgW="3206774" imgH="3365284" progId="Excel.Chart.8">
                      <p:embed/>
                      <p:pic>
                        <p:nvPicPr>
                          <p:cNvPr id="10256" name="グラフ 8">
                            <a:extLst>
                              <a:ext uri="{FF2B5EF4-FFF2-40B4-BE49-F238E27FC236}">
                                <a16:creationId xmlns:a16="http://schemas.microsoft.com/office/drawing/2014/main" id="{58CBEEFE-CFEB-4EE6-B648-50BFDF1816EB}"/>
                              </a:ext>
                            </a:extLst>
                          </p:cNvPr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3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565524" y="546101"/>
                            <a:ext cx="3203953" cy="3359149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257" name="テキスト ボックス 1">
                <a:extLst>
                  <a:ext uri="{FF2B5EF4-FFF2-40B4-BE49-F238E27FC236}">
                    <a16:creationId xmlns:a16="http://schemas.microsoft.com/office/drawing/2014/main" id="{B831CBF9-61FB-42FA-B71D-A3ED021C88D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104065" y="3600450"/>
                <a:ext cx="1274385" cy="369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kumimoji="1" lang="en-US" altLang="ja-JP" sz="900">
                    <a:latin typeface="Arial" panose="020B0604020202020204" pitchFamily="34" charset="0"/>
                    <a:cs typeface="Arial" panose="020B0604020202020204" pitchFamily="34" charset="0"/>
                  </a:rPr>
                  <a:t> children          adults</a:t>
                </a:r>
              </a:p>
              <a:p>
                <a:pPr eaLnBrk="1" hangingPunct="1"/>
                <a:r>
                  <a:rPr kumimoji="1" lang="en-US" altLang="ja-JP" sz="900">
                    <a:latin typeface="Arial" panose="020B0604020202020204" pitchFamily="34" charset="0"/>
                    <a:cs typeface="Arial" panose="020B0604020202020204" pitchFamily="34" charset="0"/>
                  </a:rPr>
                  <a:t> (n=30)           (n=81)</a:t>
                </a:r>
                <a:endParaRPr kumimoji="1" lang="ja-JP" alt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245" name="テキスト ボックス 1">
              <a:extLst>
                <a:ext uri="{FF2B5EF4-FFF2-40B4-BE49-F238E27FC236}">
                  <a16:creationId xmlns:a16="http://schemas.microsoft.com/office/drawing/2014/main" id="{8522A0AA-34F3-4830-8C4D-3A07AAC45E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5400000">
              <a:off x="-185737" y="1622065"/>
              <a:ext cx="1206502" cy="230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kumimoji="1" lang="en-US" altLang="ja-JP" sz="900">
                  <a:latin typeface="Arial" panose="020B0604020202020204" pitchFamily="34" charset="0"/>
                  <a:cs typeface="Arial" panose="020B0604020202020204" pitchFamily="34" charset="0"/>
                </a:rPr>
                <a:t>Relative Abundance</a:t>
              </a:r>
              <a:endParaRPr kumimoji="1" lang="ja-JP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46" name="テキスト ボックス 4">
              <a:extLst>
                <a:ext uri="{FF2B5EF4-FFF2-40B4-BE49-F238E27FC236}">
                  <a16:creationId xmlns:a16="http://schemas.microsoft.com/office/drawing/2014/main" id="{5EF543F9-B7C7-4019-BADE-B7BB8246F5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46477" y="1582738"/>
              <a:ext cx="317500" cy="230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kumimoji="1" lang="en-US" altLang="ja-JP" sz="900" dirty="0">
                  <a:latin typeface="Segoe UI" panose="020B0502040204020203" pitchFamily="34" charset="0"/>
                  <a:cs typeface="Segoe UI" panose="020B0502040204020203" pitchFamily="34" charset="0"/>
                </a:rPr>
                <a:t>†</a:t>
              </a:r>
            </a:p>
          </p:txBody>
        </p:sp>
        <p:sp>
          <p:nvSpPr>
            <p:cNvPr id="10247" name="テキスト ボックス 11">
              <a:extLst>
                <a:ext uri="{FF2B5EF4-FFF2-40B4-BE49-F238E27FC236}">
                  <a16:creationId xmlns:a16="http://schemas.microsoft.com/office/drawing/2014/main" id="{09EEF0C9-6A21-4F40-9D01-44B8BEB772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28988" y="1379538"/>
              <a:ext cx="26511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ja-JP" sz="900">
                  <a:latin typeface="Segoe UI" panose="020B0502040204020203" pitchFamily="34" charset="0"/>
                  <a:cs typeface="Segoe UI" panose="020B0502040204020203" pitchFamily="34" charset="0"/>
                </a:rPr>
                <a:t>*</a:t>
              </a:r>
            </a:p>
          </p:txBody>
        </p:sp>
        <p:sp>
          <p:nvSpPr>
            <p:cNvPr id="10248" name="テキスト ボックス 13">
              <a:extLst>
                <a:ext uri="{FF2B5EF4-FFF2-40B4-BE49-F238E27FC236}">
                  <a16:creationId xmlns:a16="http://schemas.microsoft.com/office/drawing/2014/main" id="{ADC3A294-DCE7-48C0-AFDA-9879C994AA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46477" y="1812925"/>
              <a:ext cx="400050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kumimoji="1" lang="en-US" altLang="ja-JP" sz="900" dirty="0">
                  <a:latin typeface="Segoe UI" panose="020B0502040204020203" pitchFamily="34" charset="0"/>
                  <a:cs typeface="Segoe UI" panose="020B0502040204020203" pitchFamily="34" charset="0"/>
                </a:rPr>
                <a:t>‡</a:t>
              </a:r>
            </a:p>
          </p:txBody>
        </p:sp>
        <p:sp>
          <p:nvSpPr>
            <p:cNvPr id="10249" name="テキスト ボックス 14">
              <a:extLst>
                <a:ext uri="{FF2B5EF4-FFF2-40B4-BE49-F238E27FC236}">
                  <a16:creationId xmlns:a16="http://schemas.microsoft.com/office/drawing/2014/main" id="{ABC246F6-3D87-4662-9064-0F79034DCC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14539" y="2124873"/>
              <a:ext cx="33020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kumimoji="1" lang="en-US" altLang="ja-JP" sz="800">
                  <a:latin typeface="Segoe UI" panose="020B0502040204020203" pitchFamily="34" charset="0"/>
                  <a:cs typeface="Segoe UI" panose="020B0502040204020203" pitchFamily="34" charset="0"/>
                </a:rPr>
                <a:t>§</a:t>
              </a:r>
            </a:p>
          </p:txBody>
        </p:sp>
        <p:sp>
          <p:nvSpPr>
            <p:cNvPr id="10250" name="テキスト ボックス 4">
              <a:extLst>
                <a:ext uri="{FF2B5EF4-FFF2-40B4-BE49-F238E27FC236}">
                  <a16:creationId xmlns:a16="http://schemas.microsoft.com/office/drawing/2014/main" id="{705AFCEE-1BD5-4B26-9EAF-1E7EB02414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54766" y="2507456"/>
              <a:ext cx="317500" cy="230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kumimoji="1" lang="en-US" altLang="ja-JP" sz="900">
                  <a:latin typeface="Segoe UI" panose="020B0502040204020203" pitchFamily="34" charset="0"/>
                  <a:cs typeface="Segoe UI" panose="020B0502040204020203" pitchFamily="34" charset="0"/>
                </a:rPr>
                <a:t>†</a:t>
              </a:r>
            </a:p>
          </p:txBody>
        </p:sp>
        <p:sp>
          <p:nvSpPr>
            <p:cNvPr id="10251" name="テキスト ボックス 11">
              <a:extLst>
                <a:ext uri="{FF2B5EF4-FFF2-40B4-BE49-F238E27FC236}">
                  <a16:creationId xmlns:a16="http://schemas.microsoft.com/office/drawing/2014/main" id="{E83612A9-FA3F-402C-848C-56759E30EB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41528" y="844323"/>
              <a:ext cx="265112" cy="230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ja-JP" sz="900" dirty="0">
                  <a:latin typeface="Segoe UI" panose="020B0502040204020203" pitchFamily="34" charset="0"/>
                  <a:cs typeface="Segoe UI" panose="020B0502040204020203" pitchFamily="34" charset="0"/>
                </a:rPr>
                <a:t>*</a:t>
              </a:r>
            </a:p>
          </p:txBody>
        </p:sp>
        <p:sp>
          <p:nvSpPr>
            <p:cNvPr id="10252" name="テキスト ボックス 13">
              <a:extLst>
                <a:ext uri="{FF2B5EF4-FFF2-40B4-BE49-F238E27FC236}">
                  <a16:creationId xmlns:a16="http://schemas.microsoft.com/office/drawing/2014/main" id="{FF1CD8B4-F756-427B-87BE-45257B2DD8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7200" y="2667793"/>
              <a:ext cx="400050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kumimoji="1" lang="en-US" altLang="ja-JP" sz="900">
                  <a:latin typeface="Segoe UI" panose="020B0502040204020203" pitchFamily="34" charset="0"/>
                  <a:cs typeface="Segoe UI" panose="020B0502040204020203" pitchFamily="34" charset="0"/>
                </a:rPr>
                <a:t>‡</a:t>
              </a:r>
            </a:p>
          </p:txBody>
        </p:sp>
        <p:sp>
          <p:nvSpPr>
            <p:cNvPr id="10253" name="テキスト ボックス 14">
              <a:extLst>
                <a:ext uri="{FF2B5EF4-FFF2-40B4-BE49-F238E27FC236}">
                  <a16:creationId xmlns:a16="http://schemas.microsoft.com/office/drawing/2014/main" id="{8B3477E0-208D-42E8-9119-A80A9CD3C7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flipH="1">
              <a:off x="2925762" y="2815435"/>
              <a:ext cx="265113" cy="2135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kumimoji="1" lang="en-US" altLang="ja-JP" sz="800">
                  <a:latin typeface="Segoe UI" panose="020B0502040204020203" pitchFamily="34" charset="0"/>
                  <a:cs typeface="Segoe UI" panose="020B0502040204020203" pitchFamily="34" charset="0"/>
                </a:rPr>
                <a:t>§</a:t>
              </a:r>
            </a:p>
          </p:txBody>
        </p:sp>
        <p:sp>
          <p:nvSpPr>
            <p:cNvPr id="10254" name="テキスト ボックス 11">
              <a:extLst>
                <a:ext uri="{FF2B5EF4-FFF2-40B4-BE49-F238E27FC236}">
                  <a16:creationId xmlns:a16="http://schemas.microsoft.com/office/drawing/2014/main" id="{6A7F34E6-FC7B-4F34-9F8A-92FCC21BFE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41528" y="2799788"/>
              <a:ext cx="2651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ja-JP" sz="800">
                  <a:latin typeface="Segoe UI" panose="020B0502040204020203" pitchFamily="34" charset="0"/>
                  <a:cs typeface="Segoe UI" panose="020B0502040204020203" pitchFamily="34" charset="0"/>
                </a:rPr>
                <a:t>||</a:t>
              </a:r>
            </a:p>
          </p:txBody>
        </p:sp>
        <p:sp>
          <p:nvSpPr>
            <p:cNvPr id="10255" name="テキスト ボックス 11">
              <a:extLst>
                <a:ext uri="{FF2B5EF4-FFF2-40B4-BE49-F238E27FC236}">
                  <a16:creationId xmlns:a16="http://schemas.microsoft.com/office/drawing/2014/main" id="{6F00AAB0-FF6A-4B3A-907E-92BA9172D3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85521" y="3087121"/>
              <a:ext cx="2651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ja-JP" sz="800">
                  <a:latin typeface="Segoe UI" panose="020B0502040204020203" pitchFamily="34" charset="0"/>
                  <a:cs typeface="Segoe UI" panose="020B0502040204020203" pitchFamily="34" charset="0"/>
                </a:rPr>
                <a:t>||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</TotalTime>
  <Words>46</Words>
  <Application>Microsoft Office PowerPoint</Application>
  <PresentationFormat>A4 210 x 297 mm</PresentationFormat>
  <Paragraphs>22</Paragraphs>
  <Slides>3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egoe UI</vt:lpstr>
      <vt:lpstr>Office テーマ</vt:lpstr>
      <vt:lpstr>Chart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奥村 俊彦</dc:creator>
  <cp:lastModifiedBy>奥村 俊彦</cp:lastModifiedBy>
  <cp:revision>10</cp:revision>
  <dcterms:created xsi:type="dcterms:W3CDTF">2021-02-16T07:53:15Z</dcterms:created>
  <dcterms:modified xsi:type="dcterms:W3CDTF">2021-02-18T08:42:52Z</dcterms:modified>
</cp:coreProperties>
</file>